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6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9" autoAdjust="0"/>
    <p:restoredTop sz="97417" autoAdjust="0"/>
  </p:normalViewPr>
  <p:slideViewPr>
    <p:cSldViewPr snapToGrid="0">
      <p:cViewPr varScale="1">
        <p:scale>
          <a:sx n="157" d="100"/>
          <a:sy n="157" d="100"/>
        </p:scale>
        <p:origin x="364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87AD54-CE6F-A979-0C7A-36CCF975C1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8FCFE53-9B66-6651-93CE-90D84F5D1E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CB0AB3-82F9-4392-588A-D10916F48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6EE667-E693-9E11-ABAF-3B0AC054B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8B311E9-E5B8-19A5-1597-EAA9CB55D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44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36F020-6120-5B96-B72B-7604C81D11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E200010-6533-8B53-AA0B-1D370C9069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8BC9B0-C524-CABD-3AFE-310348E42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9C9F32-713C-DB09-80E6-9457CF448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990CF0-A193-9D11-ECCB-CDC61EC9D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1954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B21566A-2D83-93F1-6F0F-48B91FEA95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62E5AF-FAE1-F97A-BF8E-CFB039581F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2EC279-AA43-2E2C-4941-13C0B7846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925211-98A2-9F00-BF92-9641FF088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51D023-6872-ABD0-5EED-83D8C6A6D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3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CC0E31-10CB-1002-4705-F99CC42346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FF7002-2019-C78D-6CF4-61F65EE261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6E0F26-6FF9-5E97-DE04-3F300E6AB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EB4D5C-63FF-73C6-94B8-93690D43C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BE7504-BA4F-C5DE-6F0A-C440BC15F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421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E47E3-6B66-8B53-79F1-1CCDB1745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714A647-8ACF-EEAE-0F12-1E24CE99D7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0794D1-18C3-0175-5B58-57E12C300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79FC55-0FDB-EB9D-2438-405CA051F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802AC5-4F57-E1AD-D150-A012D8831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79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39E9EA-A1F7-F22F-2B67-54C8FB9D6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9AAAA9-F74E-1675-6CC2-30A0ED072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35C74B6-8B86-70AA-A57C-F3360D8E9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4CB5A24-A4DD-BE9E-66E0-13EE332FA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28258F-0939-B4A0-0EA8-E0B6761F9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9EB669A-3E58-323A-9515-408C1E3DD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8213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0963F2-327A-5335-1557-0EC2DDB037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C16944-7326-AF66-AF13-18D472DB5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CA31E06-104D-9077-ACF2-5FF6AC4ACD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4ED7B49-70FE-1513-AC40-02BD8BEC0A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B3AC706-F2F3-A00A-C2B0-CDB9138FE5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46B6E1E-C3F8-B60C-5182-3A6B5AD55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CA61C98-5326-4565-3376-4A4412725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E3DAAE4-6075-C8A5-92FD-9C68B763A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6527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256A60-BE99-5781-2F7E-268D77EE7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1E90A68-A4AA-F37D-B512-B1392B59F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796F2EE-B4F6-3D2D-50CD-AA04B6A52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C61395E-F25A-6AB2-75CB-872C32FE7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472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A201036-10FA-F1C5-EF9E-50D58DB97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46528B0-B1DC-2062-2279-133E1ABF8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85C7FDD-5083-6022-DEF9-D6B8E3D86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997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51E740-174E-D06F-4B8A-05E887AB7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424C255-9A91-32F6-B47E-9F676C4F13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8AC143-D5DF-F535-9E58-33267E4958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A34FEC7-D58C-463C-7AC8-BDFA4422F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C517A26-7D85-57A2-7DD6-905E22141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942607-746A-E2AB-E88E-0739DE83D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02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48BED7-0DA2-FEE9-27E5-A61ECA20C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36BEE3-2B8D-1AF9-7997-4CE6604DB5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5FC295C-CAA4-CA44-937A-19614A6AB5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6B3FBA-90CE-D87E-1B32-7C2BBB7E3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83F42B-7A4B-C943-C408-72C3FA5D4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693CEB-5DDE-815E-88E9-B50E4966E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3941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1AB5912-2FFA-447F-64E0-3304D9C88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15222D-355D-0704-BF46-5993FE8A6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D086FA-63D9-1AAD-0F75-45F0FEF654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DEA8D-2276-4628-AB80-5DB7E7392D4E}" type="datetimeFigureOut">
              <a:rPr lang="zh-CN" altLang="en-US" smtClean="0"/>
              <a:t>2026/5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F6B490-6AC1-E53C-EF8A-7D94A14696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B6D409-8ACD-DCC4-7B2C-0D3D6E4057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F1E46-E54C-41CD-A5FE-34427CB982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4923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CF6136C-D1D1-28C3-CBB3-BB840A37CD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2131" y="1953133"/>
            <a:ext cx="3005171" cy="2254650"/>
          </a:xfrm>
          <a:prstGeom prst="rect">
            <a:avLst/>
          </a:prstGeom>
        </p:spPr>
      </p:pic>
      <p:pic>
        <p:nvPicPr>
          <p:cNvPr id="6" name="图片 5" descr="图表, 条形图&#10;&#10;描述已自动生成">
            <a:extLst>
              <a:ext uri="{FF2B5EF4-FFF2-40B4-BE49-F238E27FC236}">
                <a16:creationId xmlns:a16="http://schemas.microsoft.com/office/drawing/2014/main" id="{38F5CE1F-EAEB-EACE-E525-003A44D478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23" y="2099223"/>
            <a:ext cx="3280967" cy="205891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7F1C221-5750-2959-8BB8-4E007FB4C491}"/>
              </a:ext>
            </a:extLst>
          </p:cNvPr>
          <p:cNvSpPr txBox="1"/>
          <p:nvPr/>
        </p:nvSpPr>
        <p:spPr>
          <a:xfrm>
            <a:off x="2446142" y="18217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BC7EBEA-2EBB-C333-718F-1C43DAD77817}"/>
              </a:ext>
            </a:extLst>
          </p:cNvPr>
          <p:cNvSpPr txBox="1"/>
          <p:nvPr/>
        </p:nvSpPr>
        <p:spPr>
          <a:xfrm>
            <a:off x="5693746" y="182172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AD3DE8C-B091-24A6-98A1-AE359638E8F0}"/>
              </a:ext>
            </a:extLst>
          </p:cNvPr>
          <p:cNvSpPr txBox="1"/>
          <p:nvPr/>
        </p:nvSpPr>
        <p:spPr>
          <a:xfrm>
            <a:off x="2172456" y="4591140"/>
            <a:ext cx="76010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verview of metabolite identification and variation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Pie chart showing the percentage distribution of 1,233 identified metabolites across different chemical classes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Number of significantly up-regulated (red) and down-regulated (blue) metabolites in pairwise group comparisons.</a:t>
            </a:r>
          </a:p>
        </p:txBody>
      </p:sp>
    </p:spTree>
    <p:extLst>
      <p:ext uri="{BB962C8B-B14F-4D97-AF65-F5344CB8AC3E}">
        <p14:creationId xmlns:p14="http://schemas.microsoft.com/office/powerpoint/2010/main" val="2170168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表, 条形图&#10;&#10;描述已自动生成">
            <a:extLst>
              <a:ext uri="{FF2B5EF4-FFF2-40B4-BE49-F238E27FC236}">
                <a16:creationId xmlns:a16="http://schemas.microsoft.com/office/drawing/2014/main" id="{9029C4DB-40A7-6F17-3308-052DDA797D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9477" y="2217202"/>
            <a:ext cx="3779418" cy="260306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FE8C50A-D0ED-67CA-7CE4-2BD1EF8C1B62}"/>
              </a:ext>
            </a:extLst>
          </p:cNvPr>
          <p:cNvSpPr txBox="1"/>
          <p:nvPr/>
        </p:nvSpPr>
        <p:spPr>
          <a:xfrm>
            <a:off x="3263501" y="4958123"/>
            <a:ext cx="45129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umber of up-regulated (red) and down-regulated (blue) DEGs in pairwise comparisons between different groups.</a:t>
            </a:r>
          </a:p>
        </p:txBody>
      </p:sp>
    </p:spTree>
    <p:extLst>
      <p:ext uri="{BB962C8B-B14F-4D97-AF65-F5344CB8AC3E}">
        <p14:creationId xmlns:p14="http://schemas.microsoft.com/office/powerpoint/2010/main" val="23858257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FB5A0C76-7C5C-E00A-79AE-874CC80A4EA2}"/>
              </a:ext>
            </a:extLst>
          </p:cNvPr>
          <p:cNvSpPr txBox="1"/>
          <p:nvPr/>
        </p:nvSpPr>
        <p:spPr>
          <a:xfrm>
            <a:off x="922492" y="6042707"/>
            <a:ext cx="1006873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100" b="1" i="0" dirty="0">
                <a:solidFill>
                  <a:srgbClr val="222222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Figure S3. </a:t>
            </a:r>
            <a:r>
              <a:rPr lang="en-US" altLang="zh-CN" sz="1100" i="0">
                <a:solidFill>
                  <a:srgbClr val="222222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T-qPCR </a:t>
            </a:r>
            <a:r>
              <a:rPr lang="en-US" altLang="zh-CN" sz="1100" i="0" dirty="0">
                <a:solidFill>
                  <a:srgbClr val="222222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validation of selected differentially expressed genes (DEGs). 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elative expression levels of six candidate genes (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15G2501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,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04G0094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,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07G0069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,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15G0265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,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02G3054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, and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lyma.19G007700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) in figure 6 were analyzed by RT-qPCR in wild-type W82 (white bars) and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sss1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 mutant (gray bars) roots at 0, 3, and 24 hours after 150 mM NaCl treatment. Expression levels were normalized to the </a:t>
            </a:r>
            <a:r>
              <a:rPr lang="en-US" altLang="zh-CN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Actin</a:t>
            </a:r>
            <a:r>
              <a:rPr lang="en-US" altLang="zh-CN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 reference gene and are shown as mean ± SD of three biological replicates. 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903692B6-132A-F204-925A-9A4A1D1A78CB}"/>
              </a:ext>
            </a:extLst>
          </p:cNvPr>
          <p:cNvGrpSpPr/>
          <p:nvPr/>
        </p:nvGrpSpPr>
        <p:grpSpPr>
          <a:xfrm>
            <a:off x="3556076" y="23479"/>
            <a:ext cx="4559584" cy="6037516"/>
            <a:chOff x="3924268" y="233870"/>
            <a:chExt cx="4559584" cy="6037516"/>
          </a:xfrm>
        </p:grpSpPr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id="{FAC0A811-E9C1-1646-125E-DBCE0CDA32B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5422592"/>
                </p:ext>
              </p:extLst>
            </p:nvPr>
          </p:nvGraphicFramePr>
          <p:xfrm>
            <a:off x="6001512" y="233871"/>
            <a:ext cx="1979613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2" name="Prism 8" r:id="rId3" imgW="1980386" imgH="2115637" progId="Prism8.Document">
                    <p:embed/>
                  </p:oleObj>
                </mc:Choice>
                <mc:Fallback>
                  <p:oleObj name="Prism 8" r:id="rId3" imgW="1980386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001512" y="233871"/>
                          <a:ext cx="1979613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>
              <a:extLst>
                <a:ext uri="{FF2B5EF4-FFF2-40B4-BE49-F238E27FC236}">
                  <a16:creationId xmlns:a16="http://schemas.microsoft.com/office/drawing/2014/main" id="{06A6595D-AABD-1B1E-8B82-94737D705FC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25219471"/>
                </p:ext>
              </p:extLst>
            </p:nvPr>
          </p:nvGraphicFramePr>
          <p:xfrm>
            <a:off x="3944112" y="233870"/>
            <a:ext cx="2057400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3" name="Prism 8" r:id="rId5" imgW="2056735" imgH="2115637" progId="Prism8.Document">
                    <p:embed/>
                  </p:oleObj>
                </mc:Choice>
                <mc:Fallback>
                  <p:oleObj name="Prism 8" r:id="rId5" imgW="2056735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944112" y="233870"/>
                          <a:ext cx="2057400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>
              <a:extLst>
                <a:ext uri="{FF2B5EF4-FFF2-40B4-BE49-F238E27FC236}">
                  <a16:creationId xmlns:a16="http://schemas.microsoft.com/office/drawing/2014/main" id="{0E5138E3-D1FD-FF53-2E88-ABAEFDA639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9540641"/>
                </p:ext>
              </p:extLst>
            </p:nvPr>
          </p:nvGraphicFramePr>
          <p:xfrm>
            <a:off x="3924268" y="2194560"/>
            <a:ext cx="2097087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4" name="Prism 8" r:id="rId7" imgW="2096350" imgH="2115637" progId="Prism8.Document">
                    <p:embed/>
                  </p:oleObj>
                </mc:Choice>
                <mc:Fallback>
                  <p:oleObj name="Prism 8" r:id="rId7" imgW="2096350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924268" y="2194560"/>
                          <a:ext cx="2097087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>
              <a:extLst>
                <a:ext uri="{FF2B5EF4-FFF2-40B4-BE49-F238E27FC236}">
                  <a16:creationId xmlns:a16="http://schemas.microsoft.com/office/drawing/2014/main" id="{D7D1851D-C1EB-5BAA-BBB1-ECBB9BA315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56898778"/>
                </p:ext>
              </p:extLst>
            </p:nvPr>
          </p:nvGraphicFramePr>
          <p:xfrm>
            <a:off x="5884038" y="2185416"/>
            <a:ext cx="2097087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5" name="Prism 8" r:id="rId9" imgW="2096350" imgH="2115637" progId="Prism8.Document">
                    <p:embed/>
                  </p:oleObj>
                </mc:Choice>
                <mc:Fallback>
                  <p:oleObj name="Prism 8" r:id="rId9" imgW="2096350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884038" y="2185416"/>
                          <a:ext cx="2097087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>
              <a:extLst>
                <a:ext uri="{FF2B5EF4-FFF2-40B4-BE49-F238E27FC236}">
                  <a16:creationId xmlns:a16="http://schemas.microsoft.com/office/drawing/2014/main" id="{4226D104-5A5F-9706-0720-F847EF64A6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32194869"/>
                </p:ext>
              </p:extLst>
            </p:nvPr>
          </p:nvGraphicFramePr>
          <p:xfrm>
            <a:off x="3924268" y="4155249"/>
            <a:ext cx="2097087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6" name="Prism 8" r:id="rId11" imgW="2096350" imgH="2115637" progId="Prism8.Document">
                    <p:embed/>
                  </p:oleObj>
                </mc:Choice>
                <mc:Fallback>
                  <p:oleObj name="Prism 8" r:id="rId11" imgW="2096350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924268" y="4155249"/>
                          <a:ext cx="2097087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对象 8">
              <a:extLst>
                <a:ext uri="{FF2B5EF4-FFF2-40B4-BE49-F238E27FC236}">
                  <a16:creationId xmlns:a16="http://schemas.microsoft.com/office/drawing/2014/main" id="{2CC348CD-A2FB-11F9-79EC-A318AD84A5B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01979187"/>
                </p:ext>
              </p:extLst>
            </p:nvPr>
          </p:nvGraphicFramePr>
          <p:xfrm>
            <a:off x="5884038" y="4155248"/>
            <a:ext cx="2097087" cy="2116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77" name="Prism 8" r:id="rId13" imgW="2096350" imgH="2115637" progId="Prism8.Document">
                    <p:embed/>
                  </p:oleObj>
                </mc:Choice>
                <mc:Fallback>
                  <p:oleObj name="Prism 8" r:id="rId13" imgW="2096350" imgH="211563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884038" y="4155248"/>
                          <a:ext cx="2097087" cy="2116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08A3666E-97A2-A4C9-5BE1-16EA0ABE3ABA}"/>
                </a:ext>
              </a:extLst>
            </p:cNvPr>
            <p:cNvGrpSpPr/>
            <p:nvPr/>
          </p:nvGrpSpPr>
          <p:grpSpPr>
            <a:xfrm>
              <a:off x="7877674" y="345707"/>
              <a:ext cx="606178" cy="433421"/>
              <a:chOff x="4640355" y="388800"/>
              <a:chExt cx="606178" cy="433421"/>
            </a:xfrm>
          </p:grpSpPr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9B76AD5D-83DE-F7A5-565F-D7A96EFDF079}"/>
                  </a:ext>
                </a:extLst>
              </p:cNvPr>
              <p:cNvSpPr/>
              <p:nvPr/>
            </p:nvSpPr>
            <p:spPr>
              <a:xfrm>
                <a:off x="4640355" y="482335"/>
                <a:ext cx="144000" cy="7345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B7F570CC-8D63-CFF6-3F96-4FA4BE1E7DDF}"/>
                  </a:ext>
                </a:extLst>
              </p:cNvPr>
              <p:cNvSpPr/>
              <p:nvPr/>
            </p:nvSpPr>
            <p:spPr>
              <a:xfrm>
                <a:off x="4640520" y="674815"/>
                <a:ext cx="144000" cy="73459"/>
              </a:xfrm>
              <a:prstGeom prst="rect">
                <a:avLst/>
              </a:prstGeom>
              <a:solidFill>
                <a:srgbClr val="A0A0A4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11FC1FB4-0FDD-DFCB-EB57-9AEB85BF373B}"/>
                  </a:ext>
                </a:extLst>
              </p:cNvPr>
              <p:cNvSpPr txBox="1"/>
              <p:nvPr/>
            </p:nvSpPr>
            <p:spPr>
              <a:xfrm>
                <a:off x="4784355" y="388800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82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972F6F8A-3409-70FA-5CC8-BFE44BBF768F}"/>
                  </a:ext>
                </a:extLst>
              </p:cNvPr>
              <p:cNvSpPr txBox="1"/>
              <p:nvPr/>
            </p:nvSpPr>
            <p:spPr>
              <a:xfrm>
                <a:off x="4798975" y="576000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ss1</a:t>
                </a:r>
                <a:endParaRPr lang="zh-CN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61467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59</TotalTime>
  <Words>178</Words>
  <Application>Microsoft Office PowerPoint</Application>
  <PresentationFormat>宽屏</PresentationFormat>
  <Paragraphs>7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Microsoft YaHei</vt:lpstr>
      <vt:lpstr>Arial</vt:lpstr>
      <vt:lpstr>Office 主题​​</vt:lpstr>
      <vt:lpstr>Prism 8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HP</cp:lastModifiedBy>
  <cp:revision>45</cp:revision>
  <dcterms:created xsi:type="dcterms:W3CDTF">2026-03-30T07:24:19Z</dcterms:created>
  <dcterms:modified xsi:type="dcterms:W3CDTF">2026-05-29T11:02:51Z</dcterms:modified>
</cp:coreProperties>
</file>